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817914" y="1447800"/>
            <a:ext cx="6248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ea typeface="Times New Roman"/>
              </a:rPr>
              <a:t>Additional file 5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mean RPKM level of transcripts specifically expressed in one of the successive sub-apical vegetative internodes of bioenergy sorghum genotype R.07020.</a:t>
            </a:r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362200" y="2071396"/>
            <a:ext cx="5353050" cy="1822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xmlns="" val="38692155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2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4:43Z</dcterms:modified>
</cp:coreProperties>
</file>